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121" d="100"/>
          <a:sy n="121" d="100"/>
        </p:scale>
        <p:origin x="74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A06A39-C1FB-9CBC-BF43-2E6B21A5748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FC8A399-AB5A-DE8D-0A78-29E49B0EE4A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1022A01-C400-8B85-3046-5F0044DD3D13}"/>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F6D4AB9A-824E-0A14-F54E-1F5B0D9A42E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148927-9A4C-842A-EEFB-0868DF190AE3}"/>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003142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18ED7B-F196-C8E1-A190-F5AD1405CF5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727B945-0921-832F-512F-5FE52C9196A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C2F563-F9A2-40C7-57B0-9A54230C835D}"/>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3F8B899A-E017-0C07-9941-8C215DBD92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E36763-5444-5D54-F515-45FFE82E9B05}"/>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3821178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318DCD-710B-212A-6350-15ECF2180D5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FFE119C-4BC7-9E2B-9E90-648C4A3D12E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7D8912-626C-90E7-C082-A4390F155DE4}"/>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3B2E966D-17CE-CCDC-7EE3-DB7A9028C2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6F18C0-AD11-0408-2DAB-03EB4F6DEFA6}"/>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22344260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52A8DC-37B5-E91E-4054-5B9F2EDEED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1EAEE1B-618F-340F-BEB6-70DE5C57792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14688AA-7BF2-FB1F-8D7C-F26AF213B9EA}"/>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24E46CAE-354E-B247-9AA4-FB682350D4A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C9C060-9511-E72C-DAF9-A745B9B49175}"/>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30905886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A21634-1C7B-405A-8078-CC1A09900FB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4F9E96F-4D76-2DF4-8D2E-07475571438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C3FC0DF-FE50-84BC-7A93-4524D36A7F8E}"/>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5A97CBEE-6E99-C19F-CC21-F6A315B313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E3B53D-4D55-1BAD-A6D3-EF2B26BECCCE}"/>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9916656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CB6BC9-D749-DC50-8D95-0AD13A8F3E5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1CE7CB0-0F37-A487-C8D7-7E9A4978D0A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99E2810-7B26-97FC-2A5F-1CC108AC7F9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95C510D-BE87-0091-95D5-C0A5CC13FA99}"/>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6" name="Footer Placeholder 5">
            <a:extLst>
              <a:ext uri="{FF2B5EF4-FFF2-40B4-BE49-F238E27FC236}">
                <a16:creationId xmlns:a16="http://schemas.microsoft.com/office/drawing/2014/main" id="{2D7E0375-6F8E-4646-7516-2AD8FB9535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BB0638-874F-0BF6-F87E-F05460126F9E}"/>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077909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E0D830-2BD3-E7CB-3C30-8399527B6F8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E1A883D-6645-DD3E-7FF6-DACEBBBA71C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D95D8E5-50C2-E48C-0953-91F5FA7A34D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2741C15-8F94-7760-7342-742FF4EAB0C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0380D90-983C-3AAD-1744-42CACD9C2CF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7EFF1B1-EDFF-BBDA-76E1-04D459FB0ECF}"/>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8" name="Footer Placeholder 7">
            <a:extLst>
              <a:ext uri="{FF2B5EF4-FFF2-40B4-BE49-F238E27FC236}">
                <a16:creationId xmlns:a16="http://schemas.microsoft.com/office/drawing/2014/main" id="{98E29D9F-D3E6-C738-B502-68D8687AC81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DB151A7-9A4F-E722-047D-9C55D10C4D73}"/>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114121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5146AD-CDC3-C701-D26E-A958F0241E6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DD1AD5A-5748-3CCD-5B17-0A4E2FE66012}"/>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4" name="Footer Placeholder 3">
            <a:extLst>
              <a:ext uri="{FF2B5EF4-FFF2-40B4-BE49-F238E27FC236}">
                <a16:creationId xmlns:a16="http://schemas.microsoft.com/office/drawing/2014/main" id="{459C79E1-5525-2E76-90B9-A1F98110665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F156D74-F704-A397-E016-20CF5FC00B41}"/>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6263004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4C3CD4B-3B42-55AD-F5C0-713E5D898D81}"/>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3" name="Footer Placeholder 2">
            <a:extLst>
              <a:ext uri="{FF2B5EF4-FFF2-40B4-BE49-F238E27FC236}">
                <a16:creationId xmlns:a16="http://schemas.microsoft.com/office/drawing/2014/main" id="{BDD4D06B-B881-5B4B-9767-C32398B0F8B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19E679E-FB24-9D7D-9D32-23CD835F0BC0}"/>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40641459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DE500C-D3A5-1D38-8C24-DE94ECBDF60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61AE458-F277-D15D-8879-306DE6DF3CE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EE3591B-D1A9-0801-8397-A33E7CA404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323EC4-7CA4-3AE6-42B4-993210A64DD1}"/>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6" name="Footer Placeholder 5">
            <a:extLst>
              <a:ext uri="{FF2B5EF4-FFF2-40B4-BE49-F238E27FC236}">
                <a16:creationId xmlns:a16="http://schemas.microsoft.com/office/drawing/2014/main" id="{A7B04482-2F20-41D1-B276-53893EED0F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CB2A5A2-1FD0-DB03-5D31-728D490BB417}"/>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3027896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F5338-F661-62A9-F96A-279B5D295E2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6C63D7F-9EB0-C4FC-B307-E90149CD0D5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48D29F1-F9C7-B660-8DA5-9100CED23B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8A4F1E-E5E3-59AE-1A06-FB6738802572}"/>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6" name="Footer Placeholder 5">
            <a:extLst>
              <a:ext uri="{FF2B5EF4-FFF2-40B4-BE49-F238E27FC236}">
                <a16:creationId xmlns:a16="http://schemas.microsoft.com/office/drawing/2014/main" id="{BE8C6AE0-312E-8E03-FFFF-78315D1E22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B3D517-3AB4-81C9-E02B-406E9D27E3DD}"/>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41818926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6D24B3F-6BC4-ED64-0734-25B8B4484DB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0F04E2E-A6A1-785E-D249-075B5E78BC2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957B2E-59AE-ABFF-7C7B-B6B1F8D6B0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DEAEC26D-A914-A7D2-6DBA-AEFAFE78A37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74C7B47E-38C8-3B00-6ECC-A72D2C956F1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3BFC50A-7C02-E449-AB65-538CF35193F3}" type="slidenum">
              <a:rPr lang="en-US" smtClean="0"/>
              <a:t>‹#›</a:t>
            </a:fld>
            <a:endParaRPr lang="en-US"/>
          </a:p>
        </p:txBody>
      </p:sp>
    </p:spTree>
    <p:extLst>
      <p:ext uri="{BB962C8B-B14F-4D97-AF65-F5344CB8AC3E}">
        <p14:creationId xmlns:p14="http://schemas.microsoft.com/office/powerpoint/2010/main" val="32216508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A9E247C6-C951-232D-F292-64A02B37C7B6}"/>
              </a:ext>
            </a:extLst>
          </p:cNvPr>
          <p:cNvGrpSpPr/>
          <p:nvPr/>
        </p:nvGrpSpPr>
        <p:grpSpPr>
          <a:xfrm>
            <a:off x="1509309" y="0"/>
            <a:ext cx="9173382" cy="6858000"/>
            <a:chOff x="2021840" y="0"/>
            <a:chExt cx="9173382" cy="6858000"/>
          </a:xfrm>
        </p:grpSpPr>
        <p:pic>
          <p:nvPicPr>
            <p:cNvPr id="5" name="Picture 4" descr="A picture containing schematic&#10;&#10;AI-generated content may be incorrect.">
              <a:extLst>
                <a:ext uri="{FF2B5EF4-FFF2-40B4-BE49-F238E27FC236}">
                  <a16:creationId xmlns:a16="http://schemas.microsoft.com/office/drawing/2014/main" id="{1B8A364C-4244-9688-A84E-46D1DA22F312}"/>
                </a:ext>
              </a:extLst>
            </p:cNvPr>
            <p:cNvPicPr>
              <a:picLocks noChangeAspect="1"/>
            </p:cNvPicPr>
            <p:nvPr/>
          </p:nvPicPr>
          <p:blipFill>
            <a:blip r:embed="rId2"/>
            <a:stretch>
              <a:fillRect/>
            </a:stretch>
          </p:blipFill>
          <p:spPr>
            <a:xfrm>
              <a:off x="2021840" y="0"/>
              <a:ext cx="5347428" cy="6858000"/>
            </a:xfrm>
            <a:prstGeom prst="rect">
              <a:avLst/>
            </a:prstGeom>
          </p:spPr>
        </p:pic>
        <p:sp>
          <p:nvSpPr>
            <p:cNvPr id="9" name="TextBox 8">
              <a:extLst>
                <a:ext uri="{FF2B5EF4-FFF2-40B4-BE49-F238E27FC236}">
                  <a16:creationId xmlns:a16="http://schemas.microsoft.com/office/drawing/2014/main" id="{D7662734-1743-5B7F-09EC-7CDD6B8F5314}"/>
                </a:ext>
              </a:extLst>
            </p:cNvPr>
            <p:cNvSpPr txBox="1"/>
            <p:nvPr/>
          </p:nvSpPr>
          <p:spPr>
            <a:xfrm>
              <a:off x="7369268" y="1028343"/>
              <a:ext cx="3825954" cy="4801314"/>
            </a:xfrm>
            <a:prstGeom prst="rect">
              <a:avLst/>
            </a:prstGeom>
            <a:noFill/>
          </p:spPr>
          <p:txBody>
            <a:bodyPr wrap="square">
              <a:spAutoFit/>
            </a:bodyPr>
            <a:lstStyle/>
            <a:p>
              <a:pPr algn="just" rtl="0">
                <a:buNone/>
              </a:pPr>
              <a:r>
                <a:rPr lang="en-US" sz="1800" b="1" i="0" u="none" strike="noStrike" dirty="0">
                  <a:solidFill>
                    <a:srgbClr val="000000"/>
                  </a:solidFill>
                  <a:effectLst/>
                  <a:latin typeface="Times New Roman" panose="02020603050405020304" pitchFamily="18" charset="0"/>
                </a:rPr>
                <a:t>Supplementary Figure 2: Shapley Additive </a:t>
              </a:r>
              <a:r>
                <a:rPr lang="en-US" sz="1800" b="1" i="0" u="none" strike="noStrike" dirty="0" err="1">
                  <a:solidFill>
                    <a:srgbClr val="000000"/>
                  </a:solidFill>
                  <a:effectLst/>
                  <a:latin typeface="Times New Roman" panose="02020603050405020304" pitchFamily="18" charset="0"/>
                </a:rPr>
                <a:t>exPlanation</a:t>
              </a:r>
              <a:r>
                <a:rPr lang="en-US" sz="1800" b="1" i="0" u="none" strike="noStrike" dirty="0">
                  <a:solidFill>
                    <a:srgbClr val="000000"/>
                  </a:solidFill>
                  <a:effectLst/>
                  <a:latin typeface="Times New Roman" panose="02020603050405020304" pitchFamily="18" charset="0"/>
                </a:rPr>
                <a:t> (SHAP) feature importance plots.</a:t>
              </a:r>
              <a:r>
                <a:rPr lang="en-US" sz="1800" b="0" i="0" u="none" strike="noStrike" dirty="0">
                  <a:solidFill>
                    <a:srgbClr val="000000"/>
                  </a:solidFill>
                  <a:effectLst/>
                  <a:latin typeface="Times New Roman" panose="02020603050405020304" pitchFamily="18" charset="0"/>
                </a:rPr>
                <a:t> Features are ranked top to bottom from most to least important in aging. </a:t>
              </a:r>
              <a:r>
                <a:rPr lang="en-US" sz="1800" b="0" i="0" u="none" strike="noStrike" dirty="0" err="1">
                  <a:solidFill>
                    <a:srgbClr val="000000"/>
                  </a:solidFill>
                  <a:effectLst/>
                  <a:latin typeface="Times New Roman" panose="02020603050405020304" pitchFamily="18" charset="0"/>
                </a:rPr>
                <a:t>Beeswarm</a:t>
              </a:r>
              <a:r>
                <a:rPr lang="en-US" sz="1800" b="0" i="0" u="none" strike="noStrike" dirty="0">
                  <a:solidFill>
                    <a:srgbClr val="000000"/>
                  </a:solidFill>
                  <a:effectLst/>
                  <a:latin typeface="Times New Roman" panose="02020603050405020304" pitchFamily="18" charset="0"/>
                </a:rPr>
                <a:t> plots (left) display both SHAP and feature values for each individual, illuminating the direction of effect for each feature. For promoter features, this provides insights into whether age is associated with hypo- or hyper-methylation. Bar plots (right) indicate the average magnitude of effect for each feature. Top 20 features are displayed, with the combined effect of all other features aggregated at the bottom of each respective bar plot.</a:t>
              </a:r>
              <a:endParaRPr lang="en-US" b="0" dirty="0">
                <a:effectLst/>
              </a:endParaRPr>
            </a:p>
          </p:txBody>
        </p:sp>
      </p:grpSp>
    </p:spTree>
    <p:extLst>
      <p:ext uri="{BB962C8B-B14F-4D97-AF65-F5344CB8AC3E}">
        <p14:creationId xmlns:p14="http://schemas.microsoft.com/office/powerpoint/2010/main" val="3428550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3</TotalTime>
  <Words>108</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Grant, Spencer (NIH/NIA/IRP) [F]</dc:creator>
  <cp:lastModifiedBy>Grant, Spencer (NIH/NIA/IRP) [F]</cp:lastModifiedBy>
  <cp:revision>4</cp:revision>
  <dcterms:created xsi:type="dcterms:W3CDTF">2025-09-30T17:05:41Z</dcterms:created>
  <dcterms:modified xsi:type="dcterms:W3CDTF">2025-09-30T18:40:59Z</dcterms:modified>
</cp:coreProperties>
</file>